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96" r:id="rId2"/>
    <p:sldId id="297" r:id="rId3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21" userDrawn="1">
          <p15:clr>
            <a:srgbClr val="A4A3A4"/>
          </p15:clr>
        </p15:guide>
        <p15:guide id="2" pos="16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1DFDCD1-EF6B-3F80-07E7-35A56DD59C0E}" name="Charleen Chan" initials="CC" userId="S::charleen.chan@icr.ac.uk::73a26ce7-f665-4248-b705-b0b5a6e7a5b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  <a:srgbClr val="FF6699"/>
    <a:srgbClr val="CC00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04"/>
    <p:restoredTop sz="92017"/>
  </p:normalViewPr>
  <p:slideViewPr>
    <p:cSldViewPr snapToGrid="0">
      <p:cViewPr>
        <p:scale>
          <a:sx n="206" d="100"/>
          <a:sy n="206" d="100"/>
        </p:scale>
        <p:origin x="616" y="144"/>
      </p:cViewPr>
      <p:guideLst>
        <p:guide orient="horz" pos="2621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4BE0-296C-2D4A-8E47-23328EA7FFFE}" type="datetimeFigureOut">
              <a:rPr lang="en-US" smtClean="0"/>
              <a:t>10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9F04B6-F912-E44D-B4F8-91F0A2777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78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9F04B6-F912-E44D-B4F8-91F0A27773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25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936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560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420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86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8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44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57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527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618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11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07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51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8801230-3D5A-435A-7C08-B6E2D645F357}"/>
              </a:ext>
            </a:extLst>
          </p:cNvPr>
          <p:cNvSpPr txBox="1"/>
          <p:nvPr/>
        </p:nvSpPr>
        <p:spPr>
          <a:xfrm>
            <a:off x="68085" y="108783"/>
            <a:ext cx="496800" cy="365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8A07B8-9992-BB23-D204-3049CB39215E}"/>
              </a:ext>
            </a:extLst>
          </p:cNvPr>
          <p:cNvSpPr txBox="1"/>
          <p:nvPr/>
        </p:nvSpPr>
        <p:spPr>
          <a:xfrm>
            <a:off x="3466232" y="100821"/>
            <a:ext cx="496800" cy="365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4064321-5654-421D-FF18-5325024879CD}"/>
              </a:ext>
            </a:extLst>
          </p:cNvPr>
          <p:cNvSpPr txBox="1"/>
          <p:nvPr/>
        </p:nvSpPr>
        <p:spPr>
          <a:xfrm>
            <a:off x="57666" y="2790390"/>
            <a:ext cx="496800" cy="365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644096C-E3C8-AF1E-AB5E-76A0C4DB3C3F}"/>
              </a:ext>
            </a:extLst>
          </p:cNvPr>
          <p:cNvSpPr txBox="1"/>
          <p:nvPr/>
        </p:nvSpPr>
        <p:spPr>
          <a:xfrm>
            <a:off x="49913" y="5469292"/>
            <a:ext cx="496800" cy="365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B88BD8-4095-CE91-EB75-601604F060CD}"/>
              </a:ext>
            </a:extLst>
          </p:cNvPr>
          <p:cNvSpPr txBox="1"/>
          <p:nvPr/>
        </p:nvSpPr>
        <p:spPr>
          <a:xfrm>
            <a:off x="63657" y="8105666"/>
            <a:ext cx="496800" cy="365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9980276-AC20-CEE4-E38C-4639EA4089F3}"/>
              </a:ext>
            </a:extLst>
          </p:cNvPr>
          <p:cNvSpPr txBox="1"/>
          <p:nvPr/>
        </p:nvSpPr>
        <p:spPr>
          <a:xfrm>
            <a:off x="5883966" y="67753"/>
            <a:ext cx="123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3A59327-954D-FFAF-C5EE-04431DCF8E1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8269" r="8306" b="10593"/>
          <a:stretch>
            <a:fillRect/>
          </a:stretch>
        </p:blipFill>
        <p:spPr>
          <a:xfrm>
            <a:off x="185412" y="2630340"/>
            <a:ext cx="4431347" cy="277093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2F18C10-1D1E-C599-12AA-2833E77B3D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27651" y="0"/>
            <a:ext cx="3355063" cy="277368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3B5686F-48CF-2C4E-74B4-DE5852459FE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9280" y="8097846"/>
            <a:ext cx="4104640" cy="184934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5DCD458D-2391-AAB4-76DE-E6F84E0239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6476" y="436605"/>
            <a:ext cx="3658300" cy="176242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63B48A4-D558-C78D-0571-84F39F575C18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t="19549" r="24788" b="25041"/>
          <a:stretch>
            <a:fillRect/>
          </a:stretch>
        </p:blipFill>
        <p:spPr>
          <a:xfrm>
            <a:off x="260350" y="5478070"/>
            <a:ext cx="4743092" cy="2469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0988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3B5ED65-875F-896C-E7B8-9BE85020571B}"/>
              </a:ext>
            </a:extLst>
          </p:cNvPr>
          <p:cNvSpPr txBox="1"/>
          <p:nvPr/>
        </p:nvSpPr>
        <p:spPr>
          <a:xfrm>
            <a:off x="413951" y="278027"/>
            <a:ext cx="6017741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combination with CRT increases MOC1 tumour cell death but not in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EER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umour cells were pre-treated with cisplatin (5 µM),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10 µM) and/or RT 8 Gy as indicated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ell survival of MOC1 and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was assessed with Cell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it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Glo (CTG) viability assay 48 hours post-treatment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 cell death assay, whereby percentage of dead cells was shown by propidium iodide (PI) uptake, was performed 48 hours post-treatment in MOC1 and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ells. Selected statistically significant comparisons of interest highlighted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Representative pictures of cell death assay in MOC1 cells, where dead cells were shown to uptake PI (red) and nuclear staining is indicated by Hoechst (blue)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Western blot analysis of caspase-3 and PARP cleavage. Protein lysates were collected at 48 hours post-treatment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ell death assay showed the addition of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in combination with cisplatin/RT/CRT was significantly enhanced with addition of the pan-caspase inhibitor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5 µM) in the MOC1 cell line but not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Data shown from ≥2 independent experiments.</a:t>
            </a:r>
          </a:p>
        </p:txBody>
      </p:sp>
    </p:spTree>
    <p:extLst>
      <p:ext uri="{BB962C8B-B14F-4D97-AF65-F5344CB8AC3E}">
        <p14:creationId xmlns:p14="http://schemas.microsoft.com/office/powerpoint/2010/main" val="3231072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35</TotalTime>
  <Words>217</Words>
  <Application>Microsoft Macintosh PowerPoint</Application>
  <PresentationFormat>A4 Paper (210x297 mm)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nuel Patin</dc:creator>
  <cp:lastModifiedBy>Charleen Chan</cp:lastModifiedBy>
  <cp:revision>535</cp:revision>
  <cp:lastPrinted>2025-06-25T15:47:08Z</cp:lastPrinted>
  <dcterms:created xsi:type="dcterms:W3CDTF">2019-11-04T10:33:30Z</dcterms:created>
  <dcterms:modified xsi:type="dcterms:W3CDTF">2025-10-09T08:51:26Z</dcterms:modified>
</cp:coreProperties>
</file>